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36004500" cy="36004500"/>
  <p:notesSz cx="6858000" cy="9144000"/>
  <p:defaultTextStyle>
    <a:defPPr>
      <a:defRPr lang="de-DE"/>
    </a:defPPr>
    <a:lvl1pPr marL="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1pPr>
    <a:lvl2pPr marL="20574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2pPr>
    <a:lvl3pPr marL="41148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3pPr>
    <a:lvl4pPr marL="61722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4pPr>
    <a:lvl5pPr marL="82296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5pPr>
    <a:lvl6pPr marL="102870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6pPr>
    <a:lvl7pPr marL="123444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7pPr>
    <a:lvl8pPr marL="144018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8pPr>
    <a:lvl9pPr marL="164592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09" autoAdjust="0"/>
    <p:restoredTop sz="94687" autoAdjust="0"/>
  </p:normalViewPr>
  <p:slideViewPr>
    <p:cSldViewPr>
      <p:cViewPr varScale="1">
        <p:scale>
          <a:sx n="20" d="100"/>
          <a:sy n="20" d="100"/>
        </p:scale>
        <p:origin x="-1962" y="-204"/>
      </p:cViewPr>
      <p:guideLst>
        <p:guide orient="horz" pos="11340"/>
        <p:guide pos="113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L:\Paper_Entransia_Hormidiella\FIGURES\RH-des-rehydr\MSR318120_150708_12265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A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01600"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MSR318120_150708_122657!$B$28:$B$385</c:f>
              <c:numCache>
                <c:formatCode>General</c:formatCode>
                <c:ptCount val="358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</c:numCache>
            </c:numRef>
          </c:xVal>
          <c:yVal>
            <c:numRef>
              <c:f>MSR318120_150708_122657!$C$28:$C$385</c:f>
              <c:numCache>
                <c:formatCode>General</c:formatCode>
                <c:ptCount val="358"/>
                <c:pt idx="0">
                  <c:v>34.300000000000011</c:v>
                </c:pt>
                <c:pt idx="1">
                  <c:v>29.447999999999997</c:v>
                </c:pt>
                <c:pt idx="2">
                  <c:v>25.148</c:v>
                </c:pt>
                <c:pt idx="3">
                  <c:v>22.547999999999995</c:v>
                </c:pt>
                <c:pt idx="4">
                  <c:v>19.648</c:v>
                </c:pt>
                <c:pt idx="5">
                  <c:v>17.494799999999991</c:v>
                </c:pt>
                <c:pt idx="6">
                  <c:v>15.904848000000001</c:v>
                </c:pt>
                <c:pt idx="7">
                  <c:v>14.704800000000001</c:v>
                </c:pt>
                <c:pt idx="8">
                  <c:v>13.634799999999998</c:v>
                </c:pt>
                <c:pt idx="9">
                  <c:v>12.9048</c:v>
                </c:pt>
                <c:pt idx="10">
                  <c:v>12.348000000000001</c:v>
                </c:pt>
                <c:pt idx="11">
                  <c:v>11.647999999999998</c:v>
                </c:pt>
                <c:pt idx="12">
                  <c:v>11.108000000000001</c:v>
                </c:pt>
                <c:pt idx="13">
                  <c:v>10.547999999999998</c:v>
                </c:pt>
                <c:pt idx="14">
                  <c:v>10.108000000000001</c:v>
                </c:pt>
                <c:pt idx="15">
                  <c:v>9.8080000000000016</c:v>
                </c:pt>
                <c:pt idx="16">
                  <c:v>9.652000000000001</c:v>
                </c:pt>
                <c:pt idx="17">
                  <c:v>9.4479999999999986</c:v>
                </c:pt>
                <c:pt idx="18">
                  <c:v>9.3850000000000016</c:v>
                </c:pt>
                <c:pt idx="19">
                  <c:v>9.347999999999999</c:v>
                </c:pt>
                <c:pt idx="20">
                  <c:v>9.2459999999999987</c:v>
                </c:pt>
                <c:pt idx="21">
                  <c:v>9.1979999999999986</c:v>
                </c:pt>
                <c:pt idx="22">
                  <c:v>9.1479999999999997</c:v>
                </c:pt>
                <c:pt idx="23">
                  <c:v>9.1479999999999997</c:v>
                </c:pt>
                <c:pt idx="24">
                  <c:v>9.1479999999999997</c:v>
                </c:pt>
                <c:pt idx="25">
                  <c:v>9.1479999999999997</c:v>
                </c:pt>
                <c:pt idx="26">
                  <c:v>9.1479999999999997</c:v>
                </c:pt>
                <c:pt idx="27">
                  <c:v>9.1479999999999997</c:v>
                </c:pt>
                <c:pt idx="28">
                  <c:v>9.1479999999999997</c:v>
                </c:pt>
                <c:pt idx="29">
                  <c:v>9.1479999999999997</c:v>
                </c:pt>
                <c:pt idx="30">
                  <c:v>9.1479999999999997</c:v>
                </c:pt>
                <c:pt idx="31">
                  <c:v>9.1479999999999997</c:v>
                </c:pt>
                <c:pt idx="32">
                  <c:v>9.1479999999999997</c:v>
                </c:pt>
                <c:pt idx="33">
                  <c:v>9.1479999999999997</c:v>
                </c:pt>
                <c:pt idx="34">
                  <c:v>9.1479999999999997</c:v>
                </c:pt>
                <c:pt idx="35">
                  <c:v>9.1479999999999997</c:v>
                </c:pt>
                <c:pt idx="36">
                  <c:v>9.1479999999999997</c:v>
                </c:pt>
                <c:pt idx="37">
                  <c:v>9.1479999999999997</c:v>
                </c:pt>
                <c:pt idx="38">
                  <c:v>9.1479999999999997</c:v>
                </c:pt>
                <c:pt idx="39">
                  <c:v>9.1479999999999997</c:v>
                </c:pt>
                <c:pt idx="40">
                  <c:v>9.1479999999999997</c:v>
                </c:pt>
                <c:pt idx="41">
                  <c:v>9.1479999999999997</c:v>
                </c:pt>
                <c:pt idx="42">
                  <c:v>9.1479999999999997</c:v>
                </c:pt>
                <c:pt idx="43">
                  <c:v>9.1479999999999997</c:v>
                </c:pt>
                <c:pt idx="44">
                  <c:v>9.1479999999999997</c:v>
                </c:pt>
                <c:pt idx="45">
                  <c:v>9.1479999999999997</c:v>
                </c:pt>
                <c:pt idx="46">
                  <c:v>9.1479999999999997</c:v>
                </c:pt>
                <c:pt idx="47">
                  <c:v>9.1479999999999997</c:v>
                </c:pt>
                <c:pt idx="48">
                  <c:v>9.1479999999999997</c:v>
                </c:pt>
                <c:pt idx="49">
                  <c:v>9.1479999999999997</c:v>
                </c:pt>
                <c:pt idx="50">
                  <c:v>9.1479999999999997</c:v>
                </c:pt>
                <c:pt idx="51">
                  <c:v>14.147999999999998</c:v>
                </c:pt>
                <c:pt idx="52">
                  <c:v>26.148</c:v>
                </c:pt>
                <c:pt idx="53">
                  <c:v>74.147999999999996</c:v>
                </c:pt>
                <c:pt idx="54">
                  <c:v>87</c:v>
                </c:pt>
                <c:pt idx="55">
                  <c:v>92.6</c:v>
                </c:pt>
                <c:pt idx="56">
                  <c:v>94.2</c:v>
                </c:pt>
                <c:pt idx="57">
                  <c:v>94.9</c:v>
                </c:pt>
                <c:pt idx="58">
                  <c:v>95.4</c:v>
                </c:pt>
                <c:pt idx="59">
                  <c:v>95.7</c:v>
                </c:pt>
                <c:pt idx="60">
                  <c:v>96</c:v>
                </c:pt>
                <c:pt idx="61">
                  <c:v>96.2</c:v>
                </c:pt>
                <c:pt idx="62">
                  <c:v>95.9</c:v>
                </c:pt>
                <c:pt idx="63">
                  <c:v>96.1</c:v>
                </c:pt>
                <c:pt idx="64">
                  <c:v>96.2</c:v>
                </c:pt>
                <c:pt idx="65">
                  <c:v>96.3</c:v>
                </c:pt>
                <c:pt idx="66">
                  <c:v>96.4</c:v>
                </c:pt>
                <c:pt idx="67">
                  <c:v>96.5</c:v>
                </c:pt>
                <c:pt idx="68">
                  <c:v>96.6</c:v>
                </c:pt>
                <c:pt idx="69">
                  <c:v>96.7</c:v>
                </c:pt>
                <c:pt idx="70">
                  <c:v>96.8</c:v>
                </c:pt>
                <c:pt idx="71">
                  <c:v>96.6</c:v>
                </c:pt>
                <c:pt idx="72">
                  <c:v>96.4</c:v>
                </c:pt>
                <c:pt idx="73">
                  <c:v>96.5</c:v>
                </c:pt>
                <c:pt idx="74">
                  <c:v>96.5</c:v>
                </c:pt>
                <c:pt idx="75">
                  <c:v>96.4</c:v>
                </c:pt>
                <c:pt idx="76">
                  <c:v>96.4</c:v>
                </c:pt>
                <c:pt idx="77">
                  <c:v>96.2</c:v>
                </c:pt>
                <c:pt idx="78">
                  <c:v>96</c:v>
                </c:pt>
                <c:pt idx="79">
                  <c:v>96.1</c:v>
                </c:pt>
                <c:pt idx="80">
                  <c:v>96.1</c:v>
                </c:pt>
                <c:pt idx="81">
                  <c:v>96.2</c:v>
                </c:pt>
                <c:pt idx="82">
                  <c:v>96.2</c:v>
                </c:pt>
                <c:pt idx="83">
                  <c:v>96.2</c:v>
                </c:pt>
                <c:pt idx="84">
                  <c:v>96.3</c:v>
                </c:pt>
                <c:pt idx="85">
                  <c:v>96.3</c:v>
                </c:pt>
                <c:pt idx="86">
                  <c:v>96.399999999999991</c:v>
                </c:pt>
                <c:pt idx="87">
                  <c:v>96.399999999999991</c:v>
                </c:pt>
                <c:pt idx="88">
                  <c:v>96.399999999999991</c:v>
                </c:pt>
                <c:pt idx="89">
                  <c:v>96.399999999999991</c:v>
                </c:pt>
                <c:pt idx="90">
                  <c:v>96.5</c:v>
                </c:pt>
                <c:pt idx="91">
                  <c:v>96.5</c:v>
                </c:pt>
                <c:pt idx="92">
                  <c:v>96.5</c:v>
                </c:pt>
                <c:pt idx="93">
                  <c:v>96.6</c:v>
                </c:pt>
                <c:pt idx="94">
                  <c:v>96.6</c:v>
                </c:pt>
                <c:pt idx="95">
                  <c:v>96.6</c:v>
                </c:pt>
                <c:pt idx="96">
                  <c:v>96.6</c:v>
                </c:pt>
                <c:pt idx="97">
                  <c:v>96.6</c:v>
                </c:pt>
                <c:pt idx="98">
                  <c:v>96.7</c:v>
                </c:pt>
                <c:pt idx="99">
                  <c:v>96.7</c:v>
                </c:pt>
                <c:pt idx="100">
                  <c:v>96.7</c:v>
                </c:pt>
                <c:pt idx="101">
                  <c:v>96.7</c:v>
                </c:pt>
                <c:pt idx="102">
                  <c:v>96.8</c:v>
                </c:pt>
                <c:pt idx="103">
                  <c:v>96.8</c:v>
                </c:pt>
                <c:pt idx="104">
                  <c:v>96.6</c:v>
                </c:pt>
                <c:pt idx="105">
                  <c:v>96.4</c:v>
                </c:pt>
                <c:pt idx="106">
                  <c:v>96.3</c:v>
                </c:pt>
                <c:pt idx="107">
                  <c:v>96.3</c:v>
                </c:pt>
                <c:pt idx="108">
                  <c:v>96.2</c:v>
                </c:pt>
                <c:pt idx="109">
                  <c:v>96.2</c:v>
                </c:pt>
                <c:pt idx="110">
                  <c:v>96.2</c:v>
                </c:pt>
                <c:pt idx="111">
                  <c:v>96.2</c:v>
                </c:pt>
                <c:pt idx="112">
                  <c:v>96.2</c:v>
                </c:pt>
                <c:pt idx="113">
                  <c:v>96.3</c:v>
                </c:pt>
                <c:pt idx="114">
                  <c:v>96.3</c:v>
                </c:pt>
                <c:pt idx="115">
                  <c:v>96.3</c:v>
                </c:pt>
                <c:pt idx="116">
                  <c:v>96.3</c:v>
                </c:pt>
                <c:pt idx="117">
                  <c:v>96.3</c:v>
                </c:pt>
                <c:pt idx="118">
                  <c:v>96.3</c:v>
                </c:pt>
                <c:pt idx="119">
                  <c:v>96.399999999999991</c:v>
                </c:pt>
                <c:pt idx="120">
                  <c:v>96.399999999999991</c:v>
                </c:pt>
                <c:pt idx="121">
                  <c:v>96.399999999999991</c:v>
                </c:pt>
                <c:pt idx="122">
                  <c:v>96.399999999999991</c:v>
                </c:pt>
                <c:pt idx="123">
                  <c:v>96.399999999999991</c:v>
                </c:pt>
                <c:pt idx="124">
                  <c:v>96.399999999999991</c:v>
                </c:pt>
                <c:pt idx="125">
                  <c:v>96.399999999999991</c:v>
                </c:pt>
                <c:pt idx="126">
                  <c:v>96.399999999999991</c:v>
                </c:pt>
                <c:pt idx="127">
                  <c:v>96.399999999999991</c:v>
                </c:pt>
                <c:pt idx="128">
                  <c:v>96.5</c:v>
                </c:pt>
                <c:pt idx="129">
                  <c:v>96.5</c:v>
                </c:pt>
                <c:pt idx="130">
                  <c:v>96.5</c:v>
                </c:pt>
                <c:pt idx="131">
                  <c:v>96.5</c:v>
                </c:pt>
                <c:pt idx="132">
                  <c:v>96.5</c:v>
                </c:pt>
                <c:pt idx="133">
                  <c:v>96.5</c:v>
                </c:pt>
                <c:pt idx="134">
                  <c:v>96.5</c:v>
                </c:pt>
                <c:pt idx="135">
                  <c:v>96.6</c:v>
                </c:pt>
                <c:pt idx="136">
                  <c:v>96.6</c:v>
                </c:pt>
                <c:pt idx="137">
                  <c:v>96.6</c:v>
                </c:pt>
                <c:pt idx="138">
                  <c:v>96.6</c:v>
                </c:pt>
                <c:pt idx="139">
                  <c:v>96.6</c:v>
                </c:pt>
                <c:pt idx="140">
                  <c:v>96.6</c:v>
                </c:pt>
                <c:pt idx="141">
                  <c:v>96.6</c:v>
                </c:pt>
                <c:pt idx="142">
                  <c:v>96.6</c:v>
                </c:pt>
                <c:pt idx="143">
                  <c:v>96.6</c:v>
                </c:pt>
                <c:pt idx="144">
                  <c:v>96.6</c:v>
                </c:pt>
                <c:pt idx="145">
                  <c:v>96.7</c:v>
                </c:pt>
                <c:pt idx="146">
                  <c:v>96.7</c:v>
                </c:pt>
                <c:pt idx="147">
                  <c:v>96.7</c:v>
                </c:pt>
                <c:pt idx="148">
                  <c:v>96.7</c:v>
                </c:pt>
                <c:pt idx="149">
                  <c:v>96.7</c:v>
                </c:pt>
                <c:pt idx="150">
                  <c:v>96.7</c:v>
                </c:pt>
                <c:pt idx="151">
                  <c:v>96.7</c:v>
                </c:pt>
                <c:pt idx="152">
                  <c:v>96.7</c:v>
                </c:pt>
                <c:pt idx="153">
                  <c:v>96.7</c:v>
                </c:pt>
                <c:pt idx="154">
                  <c:v>96.7</c:v>
                </c:pt>
                <c:pt idx="155">
                  <c:v>96.7</c:v>
                </c:pt>
                <c:pt idx="156">
                  <c:v>96.7</c:v>
                </c:pt>
                <c:pt idx="157">
                  <c:v>96.7</c:v>
                </c:pt>
                <c:pt idx="158">
                  <c:v>96.7</c:v>
                </c:pt>
                <c:pt idx="159">
                  <c:v>96.7</c:v>
                </c:pt>
                <c:pt idx="160">
                  <c:v>96.7</c:v>
                </c:pt>
                <c:pt idx="161">
                  <c:v>96.7</c:v>
                </c:pt>
                <c:pt idx="162">
                  <c:v>96.7</c:v>
                </c:pt>
                <c:pt idx="163">
                  <c:v>96.6</c:v>
                </c:pt>
                <c:pt idx="164">
                  <c:v>96.5</c:v>
                </c:pt>
                <c:pt idx="165">
                  <c:v>96.399999999999991</c:v>
                </c:pt>
                <c:pt idx="166">
                  <c:v>96.399999999999991</c:v>
                </c:pt>
                <c:pt idx="167">
                  <c:v>96.399999999999991</c:v>
                </c:pt>
                <c:pt idx="168">
                  <c:v>96.5</c:v>
                </c:pt>
                <c:pt idx="169">
                  <c:v>96.5</c:v>
                </c:pt>
                <c:pt idx="170">
                  <c:v>96.6</c:v>
                </c:pt>
                <c:pt idx="171">
                  <c:v>96.6</c:v>
                </c:pt>
                <c:pt idx="172">
                  <c:v>96.7</c:v>
                </c:pt>
                <c:pt idx="173">
                  <c:v>96.7</c:v>
                </c:pt>
                <c:pt idx="174">
                  <c:v>96.7</c:v>
                </c:pt>
                <c:pt idx="175">
                  <c:v>96.8</c:v>
                </c:pt>
                <c:pt idx="176">
                  <c:v>96.7</c:v>
                </c:pt>
                <c:pt idx="177">
                  <c:v>96.8</c:v>
                </c:pt>
                <c:pt idx="178">
                  <c:v>96.8</c:v>
                </c:pt>
                <c:pt idx="179">
                  <c:v>96.8</c:v>
                </c:pt>
                <c:pt idx="180">
                  <c:v>96.899999999999991</c:v>
                </c:pt>
                <c:pt idx="181">
                  <c:v>96.899999999999991</c:v>
                </c:pt>
                <c:pt idx="182">
                  <c:v>96.899999999999991</c:v>
                </c:pt>
                <c:pt idx="183">
                  <c:v>96.899999999999991</c:v>
                </c:pt>
                <c:pt idx="184">
                  <c:v>96.899999999999991</c:v>
                </c:pt>
                <c:pt idx="185">
                  <c:v>96.899999999999991</c:v>
                </c:pt>
                <c:pt idx="186">
                  <c:v>97</c:v>
                </c:pt>
                <c:pt idx="187">
                  <c:v>97</c:v>
                </c:pt>
                <c:pt idx="188">
                  <c:v>97</c:v>
                </c:pt>
                <c:pt idx="189">
                  <c:v>97</c:v>
                </c:pt>
                <c:pt idx="190">
                  <c:v>97</c:v>
                </c:pt>
                <c:pt idx="191">
                  <c:v>97</c:v>
                </c:pt>
                <c:pt idx="192">
                  <c:v>97</c:v>
                </c:pt>
                <c:pt idx="193">
                  <c:v>97</c:v>
                </c:pt>
                <c:pt idx="194">
                  <c:v>97</c:v>
                </c:pt>
                <c:pt idx="195">
                  <c:v>96.9</c:v>
                </c:pt>
                <c:pt idx="196">
                  <c:v>96.7</c:v>
                </c:pt>
                <c:pt idx="197">
                  <c:v>96.6</c:v>
                </c:pt>
                <c:pt idx="198">
                  <c:v>96.5</c:v>
                </c:pt>
                <c:pt idx="199">
                  <c:v>96.5</c:v>
                </c:pt>
                <c:pt idx="200">
                  <c:v>96.6</c:v>
                </c:pt>
                <c:pt idx="201">
                  <c:v>96.6</c:v>
                </c:pt>
                <c:pt idx="202">
                  <c:v>96.7</c:v>
                </c:pt>
                <c:pt idx="203">
                  <c:v>96.7</c:v>
                </c:pt>
                <c:pt idx="204">
                  <c:v>96.7</c:v>
                </c:pt>
                <c:pt idx="205">
                  <c:v>96.8</c:v>
                </c:pt>
                <c:pt idx="206">
                  <c:v>96.7</c:v>
                </c:pt>
                <c:pt idx="207">
                  <c:v>96.8</c:v>
                </c:pt>
                <c:pt idx="208">
                  <c:v>96.8</c:v>
                </c:pt>
                <c:pt idx="209">
                  <c:v>96.7</c:v>
                </c:pt>
                <c:pt idx="210">
                  <c:v>96.7</c:v>
                </c:pt>
                <c:pt idx="211">
                  <c:v>96.7</c:v>
                </c:pt>
                <c:pt idx="212">
                  <c:v>96.7</c:v>
                </c:pt>
                <c:pt idx="213">
                  <c:v>96.7</c:v>
                </c:pt>
                <c:pt idx="214">
                  <c:v>96.7</c:v>
                </c:pt>
                <c:pt idx="215">
                  <c:v>96.7</c:v>
                </c:pt>
                <c:pt idx="216">
                  <c:v>96.7</c:v>
                </c:pt>
                <c:pt idx="217">
                  <c:v>96.7</c:v>
                </c:pt>
                <c:pt idx="218">
                  <c:v>96.7</c:v>
                </c:pt>
                <c:pt idx="219">
                  <c:v>96.7</c:v>
                </c:pt>
                <c:pt idx="220">
                  <c:v>96.7</c:v>
                </c:pt>
                <c:pt idx="221">
                  <c:v>96.6</c:v>
                </c:pt>
                <c:pt idx="222">
                  <c:v>96.5</c:v>
                </c:pt>
                <c:pt idx="223">
                  <c:v>96.399999999999991</c:v>
                </c:pt>
                <c:pt idx="224">
                  <c:v>96.399999999999991</c:v>
                </c:pt>
                <c:pt idx="225">
                  <c:v>96.399999999999991</c:v>
                </c:pt>
                <c:pt idx="226">
                  <c:v>96.5</c:v>
                </c:pt>
                <c:pt idx="227">
                  <c:v>96.5</c:v>
                </c:pt>
                <c:pt idx="228">
                  <c:v>96.6</c:v>
                </c:pt>
                <c:pt idx="229">
                  <c:v>96.6</c:v>
                </c:pt>
                <c:pt idx="230">
                  <c:v>96.7</c:v>
                </c:pt>
                <c:pt idx="231">
                  <c:v>96.7</c:v>
                </c:pt>
                <c:pt idx="232">
                  <c:v>96.7</c:v>
                </c:pt>
                <c:pt idx="233">
                  <c:v>96.7</c:v>
                </c:pt>
                <c:pt idx="234">
                  <c:v>96.7</c:v>
                </c:pt>
                <c:pt idx="235">
                  <c:v>96.7</c:v>
                </c:pt>
                <c:pt idx="236">
                  <c:v>96.8</c:v>
                </c:pt>
                <c:pt idx="237">
                  <c:v>96.8</c:v>
                </c:pt>
                <c:pt idx="238">
                  <c:v>96.6</c:v>
                </c:pt>
                <c:pt idx="239">
                  <c:v>96.4</c:v>
                </c:pt>
                <c:pt idx="240">
                  <c:v>96.3</c:v>
                </c:pt>
                <c:pt idx="241">
                  <c:v>96.3</c:v>
                </c:pt>
                <c:pt idx="242">
                  <c:v>96.2</c:v>
                </c:pt>
                <c:pt idx="243">
                  <c:v>96.2</c:v>
                </c:pt>
                <c:pt idx="244">
                  <c:v>96.2</c:v>
                </c:pt>
                <c:pt idx="245">
                  <c:v>96.2</c:v>
                </c:pt>
                <c:pt idx="246">
                  <c:v>96.2</c:v>
                </c:pt>
                <c:pt idx="247">
                  <c:v>96.3</c:v>
                </c:pt>
                <c:pt idx="248">
                  <c:v>96.3</c:v>
                </c:pt>
                <c:pt idx="249">
                  <c:v>96.3</c:v>
                </c:pt>
                <c:pt idx="250">
                  <c:v>96.3</c:v>
                </c:pt>
                <c:pt idx="251">
                  <c:v>96.3</c:v>
                </c:pt>
                <c:pt idx="252">
                  <c:v>96.3</c:v>
                </c:pt>
                <c:pt idx="253">
                  <c:v>96.399999999999991</c:v>
                </c:pt>
                <c:pt idx="254">
                  <c:v>96.399999999999991</c:v>
                </c:pt>
                <c:pt idx="255">
                  <c:v>96.399999999999991</c:v>
                </c:pt>
                <c:pt idx="256">
                  <c:v>96.399999999999991</c:v>
                </c:pt>
                <c:pt idx="257">
                  <c:v>96.399999999999991</c:v>
                </c:pt>
                <c:pt idx="258">
                  <c:v>96.399999999999991</c:v>
                </c:pt>
                <c:pt idx="259">
                  <c:v>96.399999999999991</c:v>
                </c:pt>
                <c:pt idx="260">
                  <c:v>96.399999999999991</c:v>
                </c:pt>
                <c:pt idx="261">
                  <c:v>96.399999999999991</c:v>
                </c:pt>
                <c:pt idx="262">
                  <c:v>96.5</c:v>
                </c:pt>
                <c:pt idx="263">
                  <c:v>96.5</c:v>
                </c:pt>
                <c:pt idx="264">
                  <c:v>96.5</c:v>
                </c:pt>
                <c:pt idx="265">
                  <c:v>96.7</c:v>
                </c:pt>
                <c:pt idx="266">
                  <c:v>96.7</c:v>
                </c:pt>
                <c:pt idx="267">
                  <c:v>96.7</c:v>
                </c:pt>
                <c:pt idx="268">
                  <c:v>96.7</c:v>
                </c:pt>
                <c:pt idx="269">
                  <c:v>96.7</c:v>
                </c:pt>
                <c:pt idx="270">
                  <c:v>96.6</c:v>
                </c:pt>
                <c:pt idx="271">
                  <c:v>96.5</c:v>
                </c:pt>
                <c:pt idx="272">
                  <c:v>96.399999999999991</c:v>
                </c:pt>
                <c:pt idx="273">
                  <c:v>96.399999999999991</c:v>
                </c:pt>
                <c:pt idx="274">
                  <c:v>96.399999999999991</c:v>
                </c:pt>
                <c:pt idx="275">
                  <c:v>96.5</c:v>
                </c:pt>
                <c:pt idx="276">
                  <c:v>96.5</c:v>
                </c:pt>
                <c:pt idx="277">
                  <c:v>96.6</c:v>
                </c:pt>
                <c:pt idx="278">
                  <c:v>96.6</c:v>
                </c:pt>
                <c:pt idx="279">
                  <c:v>96.7</c:v>
                </c:pt>
                <c:pt idx="280">
                  <c:v>96.7</c:v>
                </c:pt>
                <c:pt idx="281">
                  <c:v>96.7</c:v>
                </c:pt>
                <c:pt idx="282">
                  <c:v>96.7</c:v>
                </c:pt>
                <c:pt idx="283">
                  <c:v>96.7</c:v>
                </c:pt>
                <c:pt idx="284">
                  <c:v>96.7</c:v>
                </c:pt>
                <c:pt idx="285">
                  <c:v>96.8</c:v>
                </c:pt>
                <c:pt idx="286">
                  <c:v>96.8</c:v>
                </c:pt>
                <c:pt idx="287">
                  <c:v>96.6</c:v>
                </c:pt>
                <c:pt idx="288">
                  <c:v>96.4</c:v>
                </c:pt>
                <c:pt idx="289">
                  <c:v>96.3</c:v>
                </c:pt>
                <c:pt idx="290">
                  <c:v>96.3</c:v>
                </c:pt>
                <c:pt idx="291">
                  <c:v>96.399999999999991</c:v>
                </c:pt>
                <c:pt idx="292">
                  <c:v>96.399999999999991</c:v>
                </c:pt>
                <c:pt idx="293">
                  <c:v>96.5</c:v>
                </c:pt>
                <c:pt idx="294">
                  <c:v>96.5</c:v>
                </c:pt>
                <c:pt idx="295">
                  <c:v>96.6</c:v>
                </c:pt>
                <c:pt idx="296">
                  <c:v>96.6</c:v>
                </c:pt>
                <c:pt idx="297">
                  <c:v>96.7</c:v>
                </c:pt>
                <c:pt idx="298">
                  <c:v>96.7</c:v>
                </c:pt>
                <c:pt idx="299">
                  <c:v>96.7</c:v>
                </c:pt>
                <c:pt idx="300">
                  <c:v>96.8</c:v>
                </c:pt>
                <c:pt idx="301">
                  <c:v>96.7</c:v>
                </c:pt>
                <c:pt idx="302">
                  <c:v>96.8</c:v>
                </c:pt>
                <c:pt idx="303">
                  <c:v>96.8</c:v>
                </c:pt>
                <c:pt idx="304">
                  <c:v>96.8</c:v>
                </c:pt>
                <c:pt idx="305">
                  <c:v>96.899999999999991</c:v>
                </c:pt>
                <c:pt idx="306">
                  <c:v>96.899999999999991</c:v>
                </c:pt>
                <c:pt idx="307">
                  <c:v>96.899999999999991</c:v>
                </c:pt>
                <c:pt idx="308">
                  <c:v>96.899999999999991</c:v>
                </c:pt>
                <c:pt idx="309">
                  <c:v>96.899999999999991</c:v>
                </c:pt>
                <c:pt idx="310">
                  <c:v>96.6</c:v>
                </c:pt>
                <c:pt idx="311">
                  <c:v>96.7</c:v>
                </c:pt>
                <c:pt idx="312">
                  <c:v>96.7</c:v>
                </c:pt>
                <c:pt idx="313">
                  <c:v>96.7</c:v>
                </c:pt>
                <c:pt idx="314">
                  <c:v>96.8</c:v>
                </c:pt>
                <c:pt idx="315">
                  <c:v>96.7</c:v>
                </c:pt>
                <c:pt idx="316">
                  <c:v>96.8</c:v>
                </c:pt>
                <c:pt idx="317">
                  <c:v>96.8</c:v>
                </c:pt>
                <c:pt idx="318">
                  <c:v>96.7</c:v>
                </c:pt>
                <c:pt idx="319">
                  <c:v>96.7</c:v>
                </c:pt>
                <c:pt idx="320">
                  <c:v>96.7</c:v>
                </c:pt>
                <c:pt idx="321">
                  <c:v>96.7</c:v>
                </c:pt>
                <c:pt idx="322">
                  <c:v>96.7</c:v>
                </c:pt>
                <c:pt idx="323">
                  <c:v>96.7</c:v>
                </c:pt>
                <c:pt idx="324">
                  <c:v>96.7</c:v>
                </c:pt>
                <c:pt idx="325">
                  <c:v>96.7</c:v>
                </c:pt>
                <c:pt idx="326">
                  <c:v>96.7</c:v>
                </c:pt>
                <c:pt idx="327">
                  <c:v>96.7</c:v>
                </c:pt>
                <c:pt idx="328">
                  <c:v>96.7</c:v>
                </c:pt>
                <c:pt idx="329">
                  <c:v>96.7</c:v>
                </c:pt>
                <c:pt idx="330">
                  <c:v>96.6</c:v>
                </c:pt>
                <c:pt idx="331">
                  <c:v>96.6</c:v>
                </c:pt>
                <c:pt idx="332">
                  <c:v>96.4</c:v>
                </c:pt>
                <c:pt idx="333">
                  <c:v>96.3</c:v>
                </c:pt>
                <c:pt idx="334">
                  <c:v>96.3</c:v>
                </c:pt>
                <c:pt idx="335">
                  <c:v>96.2</c:v>
                </c:pt>
                <c:pt idx="336">
                  <c:v>96.2</c:v>
                </c:pt>
                <c:pt idx="337">
                  <c:v>96.2</c:v>
                </c:pt>
                <c:pt idx="338">
                  <c:v>96.2</c:v>
                </c:pt>
                <c:pt idx="339">
                  <c:v>96.2</c:v>
                </c:pt>
                <c:pt idx="340">
                  <c:v>96.3</c:v>
                </c:pt>
                <c:pt idx="341">
                  <c:v>96.3</c:v>
                </c:pt>
                <c:pt idx="342">
                  <c:v>96.3</c:v>
                </c:pt>
                <c:pt idx="343">
                  <c:v>96.3</c:v>
                </c:pt>
                <c:pt idx="344">
                  <c:v>96.3</c:v>
                </c:pt>
                <c:pt idx="345">
                  <c:v>96.3</c:v>
                </c:pt>
                <c:pt idx="346">
                  <c:v>96.39999999999999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8559744"/>
        <c:axId val="148561280"/>
      </c:scatterChart>
      <c:scatterChart>
        <c:scatterStyle val="lineMarker"/>
        <c:varyColors val="0"/>
        <c:ser>
          <c:idx val="1"/>
          <c:order val="1"/>
          <c:spPr>
            <a:ln w="101600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MSR318120_150708_122657!$B$28:$B$385</c:f>
              <c:numCache>
                <c:formatCode>General</c:formatCode>
                <c:ptCount val="358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</c:numCache>
            </c:numRef>
          </c:xVal>
          <c:yVal>
            <c:numRef>
              <c:f>MSR318120_150708_122657!$D$28:$D$385</c:f>
              <c:numCache>
                <c:formatCode>General</c:formatCode>
                <c:ptCount val="358"/>
                <c:pt idx="0">
                  <c:v>24.637103915527302</c:v>
                </c:pt>
                <c:pt idx="1">
                  <c:v>23.8371027711182</c:v>
                </c:pt>
                <c:pt idx="2">
                  <c:v>23.457103610351602</c:v>
                </c:pt>
                <c:pt idx="3">
                  <c:v>23.397102237060498</c:v>
                </c:pt>
                <c:pt idx="4">
                  <c:v>23.407102465942401</c:v>
                </c:pt>
                <c:pt idx="5">
                  <c:v>23.437103152587902</c:v>
                </c:pt>
                <c:pt idx="6">
                  <c:v>23.427102923706098</c:v>
                </c:pt>
                <c:pt idx="7">
                  <c:v>23.2971037629395</c:v>
                </c:pt>
                <c:pt idx="8">
                  <c:v>23.0171030762939</c:v>
                </c:pt>
                <c:pt idx="9">
                  <c:v>22.8371027711182</c:v>
                </c:pt>
                <c:pt idx="10">
                  <c:v>22.737102389648399</c:v>
                </c:pt>
                <c:pt idx="11">
                  <c:v>22.647102237060498</c:v>
                </c:pt>
                <c:pt idx="12">
                  <c:v>22.637103915527302</c:v>
                </c:pt>
                <c:pt idx="13">
                  <c:v>22.557102084472699</c:v>
                </c:pt>
                <c:pt idx="14">
                  <c:v>22.5171030762939</c:v>
                </c:pt>
                <c:pt idx="15">
                  <c:v>22.457103610351602</c:v>
                </c:pt>
                <c:pt idx="16">
                  <c:v>22.407102465942401</c:v>
                </c:pt>
                <c:pt idx="17">
                  <c:v>22.367103457763697</c:v>
                </c:pt>
                <c:pt idx="18">
                  <c:v>22.377103686645501</c:v>
                </c:pt>
                <c:pt idx="19">
                  <c:v>22.377103686645501</c:v>
                </c:pt>
                <c:pt idx="20">
                  <c:v>22.417102694824202</c:v>
                </c:pt>
                <c:pt idx="21">
                  <c:v>22.457103610351602</c:v>
                </c:pt>
                <c:pt idx="22">
                  <c:v>22.557102084472699</c:v>
                </c:pt>
                <c:pt idx="23">
                  <c:v>22.437103152587902</c:v>
                </c:pt>
                <c:pt idx="24">
                  <c:v>22.3371027711182</c:v>
                </c:pt>
                <c:pt idx="25">
                  <c:v>22.277103305175796</c:v>
                </c:pt>
                <c:pt idx="26">
                  <c:v>22.237102389648399</c:v>
                </c:pt>
                <c:pt idx="27">
                  <c:v>22.187103152587902</c:v>
                </c:pt>
                <c:pt idx="28">
                  <c:v>22.147102237060498</c:v>
                </c:pt>
                <c:pt idx="29">
                  <c:v>22.097103000000001</c:v>
                </c:pt>
                <c:pt idx="30">
                  <c:v>22.077102542236297</c:v>
                </c:pt>
                <c:pt idx="31">
                  <c:v>22.0471037629395</c:v>
                </c:pt>
                <c:pt idx="32">
                  <c:v>22.3371027711182</c:v>
                </c:pt>
                <c:pt idx="33">
                  <c:v>22.237102389648399</c:v>
                </c:pt>
                <c:pt idx="34">
                  <c:v>22.347102237060497</c:v>
                </c:pt>
                <c:pt idx="35">
                  <c:v>22.437103915527295</c:v>
                </c:pt>
                <c:pt idx="36">
                  <c:v>22.3571020844727</c:v>
                </c:pt>
                <c:pt idx="37">
                  <c:v>22.257102847412099</c:v>
                </c:pt>
                <c:pt idx="38">
                  <c:v>22.277103305175796</c:v>
                </c:pt>
                <c:pt idx="39">
                  <c:v>22.257102847412099</c:v>
                </c:pt>
                <c:pt idx="40">
                  <c:v>22.247102618530295</c:v>
                </c:pt>
                <c:pt idx="41">
                  <c:v>22.3371027711182</c:v>
                </c:pt>
                <c:pt idx="42">
                  <c:v>22.237102389648399</c:v>
                </c:pt>
                <c:pt idx="43">
                  <c:v>22.347102237060497</c:v>
                </c:pt>
                <c:pt idx="44">
                  <c:v>22.437103915527295</c:v>
                </c:pt>
                <c:pt idx="45">
                  <c:v>22.3571020844727</c:v>
                </c:pt>
                <c:pt idx="46">
                  <c:v>22.257102847412099</c:v>
                </c:pt>
                <c:pt idx="47">
                  <c:v>22.277103305175796</c:v>
                </c:pt>
                <c:pt idx="48">
                  <c:v>22.237102389648399</c:v>
                </c:pt>
                <c:pt idx="49">
                  <c:v>22.347102237060497</c:v>
                </c:pt>
                <c:pt idx="50">
                  <c:v>22.437103915527295</c:v>
                </c:pt>
                <c:pt idx="51">
                  <c:v>23.427102923706098</c:v>
                </c:pt>
                <c:pt idx="52">
                  <c:v>23.2971037629395</c:v>
                </c:pt>
                <c:pt idx="53">
                  <c:v>23.0171030762939</c:v>
                </c:pt>
                <c:pt idx="54">
                  <c:v>22.8371027711182</c:v>
                </c:pt>
                <c:pt idx="55">
                  <c:v>22.5471037629395</c:v>
                </c:pt>
                <c:pt idx="56">
                  <c:v>22.477102160766602</c:v>
                </c:pt>
                <c:pt idx="57">
                  <c:v>22.407102465942401</c:v>
                </c:pt>
                <c:pt idx="58">
                  <c:v>22.427102923706098</c:v>
                </c:pt>
                <c:pt idx="59">
                  <c:v>22.367103457763697</c:v>
                </c:pt>
                <c:pt idx="60">
                  <c:v>22.367103457763697</c:v>
                </c:pt>
                <c:pt idx="61">
                  <c:v>22.2971037629395</c:v>
                </c:pt>
                <c:pt idx="62">
                  <c:v>22.2971037629395</c:v>
                </c:pt>
                <c:pt idx="63">
                  <c:v>22.2971037629395</c:v>
                </c:pt>
                <c:pt idx="64">
                  <c:v>22.257102847412099</c:v>
                </c:pt>
                <c:pt idx="65">
                  <c:v>22.287103534057596</c:v>
                </c:pt>
                <c:pt idx="66">
                  <c:v>22.267103076293896</c:v>
                </c:pt>
                <c:pt idx="67">
                  <c:v>22.257102847412099</c:v>
                </c:pt>
                <c:pt idx="68">
                  <c:v>22.257102847412099</c:v>
                </c:pt>
                <c:pt idx="69">
                  <c:v>22.277103305175796</c:v>
                </c:pt>
                <c:pt idx="70">
                  <c:v>22.257102847412099</c:v>
                </c:pt>
                <c:pt idx="71">
                  <c:v>22.247102618530295</c:v>
                </c:pt>
                <c:pt idx="72">
                  <c:v>22.237102389648399</c:v>
                </c:pt>
                <c:pt idx="73">
                  <c:v>22.277103305175796</c:v>
                </c:pt>
                <c:pt idx="74">
                  <c:v>22.247102618530295</c:v>
                </c:pt>
                <c:pt idx="75">
                  <c:v>22.257102847412099</c:v>
                </c:pt>
                <c:pt idx="76">
                  <c:v>22.237102389648399</c:v>
                </c:pt>
                <c:pt idx="77">
                  <c:v>22.247102618530295</c:v>
                </c:pt>
                <c:pt idx="78">
                  <c:v>22.237102389648399</c:v>
                </c:pt>
                <c:pt idx="79">
                  <c:v>22.257102847412099</c:v>
                </c:pt>
                <c:pt idx="80">
                  <c:v>22.257102847412099</c:v>
                </c:pt>
                <c:pt idx="81">
                  <c:v>22.267103076293896</c:v>
                </c:pt>
                <c:pt idx="82">
                  <c:v>22.257102847412099</c:v>
                </c:pt>
                <c:pt idx="83">
                  <c:v>22.237102389648399</c:v>
                </c:pt>
                <c:pt idx="84">
                  <c:v>22.227102160766602</c:v>
                </c:pt>
                <c:pt idx="85">
                  <c:v>22.217103839233395</c:v>
                </c:pt>
                <c:pt idx="86">
                  <c:v>22.217103839233395</c:v>
                </c:pt>
                <c:pt idx="87">
                  <c:v>22.217103839233395</c:v>
                </c:pt>
                <c:pt idx="88">
                  <c:v>22.197103381469702</c:v>
                </c:pt>
                <c:pt idx="89">
                  <c:v>22.227102160766602</c:v>
                </c:pt>
                <c:pt idx="90">
                  <c:v>22.207103610351602</c:v>
                </c:pt>
                <c:pt idx="91">
                  <c:v>22.207103610351602</c:v>
                </c:pt>
                <c:pt idx="92">
                  <c:v>22.187103152587902</c:v>
                </c:pt>
                <c:pt idx="93">
                  <c:v>22.197103381469702</c:v>
                </c:pt>
                <c:pt idx="94">
                  <c:v>22.177102923706101</c:v>
                </c:pt>
                <c:pt idx="95">
                  <c:v>22.187103152587902</c:v>
                </c:pt>
                <c:pt idx="96">
                  <c:v>22.197103381469702</c:v>
                </c:pt>
                <c:pt idx="97">
                  <c:v>22.207103610351602</c:v>
                </c:pt>
                <c:pt idx="98">
                  <c:v>22.157102465942405</c:v>
                </c:pt>
                <c:pt idx="99">
                  <c:v>22.177102923706101</c:v>
                </c:pt>
                <c:pt idx="100">
                  <c:v>22.157102465942405</c:v>
                </c:pt>
                <c:pt idx="101">
                  <c:v>22.157102465942405</c:v>
                </c:pt>
                <c:pt idx="102">
                  <c:v>22.177102923706101</c:v>
                </c:pt>
                <c:pt idx="103">
                  <c:v>22.147102237060498</c:v>
                </c:pt>
                <c:pt idx="104">
                  <c:v>22.137103915527302</c:v>
                </c:pt>
                <c:pt idx="105">
                  <c:v>22.167102694824202</c:v>
                </c:pt>
                <c:pt idx="106">
                  <c:v>22.167102694824202</c:v>
                </c:pt>
                <c:pt idx="107">
                  <c:v>22.177102923706101</c:v>
                </c:pt>
                <c:pt idx="108">
                  <c:v>22.147102237060498</c:v>
                </c:pt>
                <c:pt idx="109">
                  <c:v>22.147102237060498</c:v>
                </c:pt>
                <c:pt idx="110">
                  <c:v>22.157102465942405</c:v>
                </c:pt>
                <c:pt idx="111">
                  <c:v>22.137103915527302</c:v>
                </c:pt>
                <c:pt idx="112">
                  <c:v>22.147102237060498</c:v>
                </c:pt>
                <c:pt idx="113">
                  <c:v>22.147102237060498</c:v>
                </c:pt>
                <c:pt idx="114">
                  <c:v>22.117103457763701</c:v>
                </c:pt>
                <c:pt idx="115">
                  <c:v>22.127103686645501</c:v>
                </c:pt>
                <c:pt idx="116">
                  <c:v>22.127103686645501</c:v>
                </c:pt>
                <c:pt idx="117">
                  <c:v>22.137103915527302</c:v>
                </c:pt>
                <c:pt idx="118">
                  <c:v>22.127103686645501</c:v>
                </c:pt>
                <c:pt idx="119">
                  <c:v>22.117103457763701</c:v>
                </c:pt>
                <c:pt idx="120">
                  <c:v>22.127103686645501</c:v>
                </c:pt>
                <c:pt idx="121">
                  <c:v>22.117103457763701</c:v>
                </c:pt>
                <c:pt idx="122">
                  <c:v>22.107103228881801</c:v>
                </c:pt>
                <c:pt idx="123">
                  <c:v>22.097103000000001</c:v>
                </c:pt>
                <c:pt idx="124">
                  <c:v>22.077102542236297</c:v>
                </c:pt>
                <c:pt idx="125">
                  <c:v>22.097103000000001</c:v>
                </c:pt>
                <c:pt idx="126">
                  <c:v>22.087102771118197</c:v>
                </c:pt>
                <c:pt idx="127">
                  <c:v>22.077102542236297</c:v>
                </c:pt>
                <c:pt idx="128">
                  <c:v>22.097103000000001</c:v>
                </c:pt>
                <c:pt idx="129">
                  <c:v>22.077102542236297</c:v>
                </c:pt>
                <c:pt idx="130">
                  <c:v>22.0671023133545</c:v>
                </c:pt>
                <c:pt idx="131">
                  <c:v>22.077102542236297</c:v>
                </c:pt>
                <c:pt idx="132">
                  <c:v>22.0671023133545</c:v>
                </c:pt>
                <c:pt idx="133">
                  <c:v>22.057102084472699</c:v>
                </c:pt>
                <c:pt idx="134">
                  <c:v>22.057102084472699</c:v>
                </c:pt>
                <c:pt idx="135">
                  <c:v>22.057102084472699</c:v>
                </c:pt>
                <c:pt idx="136">
                  <c:v>22.057102084472699</c:v>
                </c:pt>
                <c:pt idx="137">
                  <c:v>22.097103000000001</c:v>
                </c:pt>
                <c:pt idx="138">
                  <c:v>22.0671023133545</c:v>
                </c:pt>
                <c:pt idx="139">
                  <c:v>22.057102084472699</c:v>
                </c:pt>
                <c:pt idx="140">
                  <c:v>22.057102084472699</c:v>
                </c:pt>
                <c:pt idx="141">
                  <c:v>22.027103305175796</c:v>
                </c:pt>
                <c:pt idx="142">
                  <c:v>22.027103305175796</c:v>
                </c:pt>
                <c:pt idx="143">
                  <c:v>22.007102847412099</c:v>
                </c:pt>
                <c:pt idx="144">
                  <c:v>21.967103839233392</c:v>
                </c:pt>
                <c:pt idx="145">
                  <c:v>21.967103839233392</c:v>
                </c:pt>
                <c:pt idx="146">
                  <c:v>21.947103381469699</c:v>
                </c:pt>
                <c:pt idx="147">
                  <c:v>21.907102465942401</c:v>
                </c:pt>
                <c:pt idx="148">
                  <c:v>21.917102694824202</c:v>
                </c:pt>
                <c:pt idx="149">
                  <c:v>21.937103152587902</c:v>
                </c:pt>
                <c:pt idx="150">
                  <c:v>21.917102694824202</c:v>
                </c:pt>
                <c:pt idx="151">
                  <c:v>21.917102694824202</c:v>
                </c:pt>
                <c:pt idx="152">
                  <c:v>21.877103686645501</c:v>
                </c:pt>
                <c:pt idx="153">
                  <c:v>21.995710322888097</c:v>
                </c:pt>
                <c:pt idx="154">
                  <c:v>21.998971022370601</c:v>
                </c:pt>
                <c:pt idx="155">
                  <c:v>22.077102542236297</c:v>
                </c:pt>
                <c:pt idx="156">
                  <c:v>22.277103305175796</c:v>
                </c:pt>
                <c:pt idx="157">
                  <c:v>22.417102694824202</c:v>
                </c:pt>
                <c:pt idx="158">
                  <c:v>22.457103610351602</c:v>
                </c:pt>
                <c:pt idx="159">
                  <c:v>22.297102618530296</c:v>
                </c:pt>
                <c:pt idx="160">
                  <c:v>22.271020844726994</c:v>
                </c:pt>
                <c:pt idx="161">
                  <c:v>22.477102160766602</c:v>
                </c:pt>
                <c:pt idx="162">
                  <c:v>22.2971037629395</c:v>
                </c:pt>
                <c:pt idx="163">
                  <c:v>22.087102771118197</c:v>
                </c:pt>
                <c:pt idx="164">
                  <c:v>22.2509901185303</c:v>
                </c:pt>
                <c:pt idx="165">
                  <c:v>22.170991339233399</c:v>
                </c:pt>
                <c:pt idx="166">
                  <c:v>22.310989584472701</c:v>
                </c:pt>
                <c:pt idx="167">
                  <c:v>22.510991110351604</c:v>
                </c:pt>
                <c:pt idx="168">
                  <c:v>22.230991186645504</c:v>
                </c:pt>
                <c:pt idx="169">
                  <c:v>22.550991262939501</c:v>
                </c:pt>
                <c:pt idx="170">
                  <c:v>22.4909898896484</c:v>
                </c:pt>
                <c:pt idx="171">
                  <c:v>22.4509908814697</c:v>
                </c:pt>
                <c:pt idx="172">
                  <c:v>22.390991415527303</c:v>
                </c:pt>
                <c:pt idx="173">
                  <c:v>22.350990500000005</c:v>
                </c:pt>
                <c:pt idx="174">
                  <c:v>22.330990042236301</c:v>
                </c:pt>
                <c:pt idx="175">
                  <c:v>22.320989813354501</c:v>
                </c:pt>
                <c:pt idx="176">
                  <c:v>22.270990576293897</c:v>
                </c:pt>
                <c:pt idx="177">
                  <c:v>22.280990805175794</c:v>
                </c:pt>
                <c:pt idx="178">
                  <c:v>22.2409898896484</c:v>
                </c:pt>
                <c:pt idx="179">
                  <c:v>22.2509901185303</c:v>
                </c:pt>
                <c:pt idx="180">
                  <c:v>22.2009908814697</c:v>
                </c:pt>
                <c:pt idx="181">
                  <c:v>22.2009908814697</c:v>
                </c:pt>
                <c:pt idx="182">
                  <c:v>22.190990652587903</c:v>
                </c:pt>
                <c:pt idx="183">
                  <c:v>22.170990194824206</c:v>
                </c:pt>
                <c:pt idx="184">
                  <c:v>22.180990423706106</c:v>
                </c:pt>
                <c:pt idx="185">
                  <c:v>22.170990194824206</c:v>
                </c:pt>
                <c:pt idx="186">
                  <c:v>22.13099118664551</c:v>
                </c:pt>
                <c:pt idx="187">
                  <c:v>22.120990957763702</c:v>
                </c:pt>
                <c:pt idx="188">
                  <c:v>22.150989737060506</c:v>
                </c:pt>
                <c:pt idx="189">
                  <c:v>22.13099118664551</c:v>
                </c:pt>
                <c:pt idx="190">
                  <c:v>22.120990957763702</c:v>
                </c:pt>
                <c:pt idx="191">
                  <c:v>22.110990728881809</c:v>
                </c:pt>
                <c:pt idx="192">
                  <c:v>22.110990728881809</c:v>
                </c:pt>
                <c:pt idx="193">
                  <c:v>22.110990728881809</c:v>
                </c:pt>
                <c:pt idx="194">
                  <c:v>22.110990728881809</c:v>
                </c:pt>
                <c:pt idx="195">
                  <c:v>22.450990118530299</c:v>
                </c:pt>
                <c:pt idx="196">
                  <c:v>22.170991339233399</c:v>
                </c:pt>
                <c:pt idx="197">
                  <c:v>22.310989584472701</c:v>
                </c:pt>
                <c:pt idx="198">
                  <c:v>22.310991110351605</c:v>
                </c:pt>
                <c:pt idx="199">
                  <c:v>22.2009908814697</c:v>
                </c:pt>
                <c:pt idx="200">
                  <c:v>22.190990652587903</c:v>
                </c:pt>
                <c:pt idx="201">
                  <c:v>22.170990194824206</c:v>
                </c:pt>
                <c:pt idx="202">
                  <c:v>22.477102160766602</c:v>
                </c:pt>
                <c:pt idx="203">
                  <c:v>22.2971037629395</c:v>
                </c:pt>
                <c:pt idx="204">
                  <c:v>22.087102771118197</c:v>
                </c:pt>
                <c:pt idx="205">
                  <c:v>22.450990118530299</c:v>
                </c:pt>
                <c:pt idx="206">
                  <c:v>22.170991339233399</c:v>
                </c:pt>
                <c:pt idx="207">
                  <c:v>22.410989584472699</c:v>
                </c:pt>
                <c:pt idx="208">
                  <c:v>22.390991415527303</c:v>
                </c:pt>
                <c:pt idx="209">
                  <c:v>22.097103000000001</c:v>
                </c:pt>
                <c:pt idx="210">
                  <c:v>22.087102771118197</c:v>
                </c:pt>
                <c:pt idx="211">
                  <c:v>22.077102542236297</c:v>
                </c:pt>
                <c:pt idx="212">
                  <c:v>22.097103000000001</c:v>
                </c:pt>
                <c:pt idx="213">
                  <c:v>22.077102542236297</c:v>
                </c:pt>
                <c:pt idx="214">
                  <c:v>22.0671023133545</c:v>
                </c:pt>
                <c:pt idx="215">
                  <c:v>22.077102542236297</c:v>
                </c:pt>
                <c:pt idx="216">
                  <c:v>22.0671023133545</c:v>
                </c:pt>
                <c:pt idx="217">
                  <c:v>22.057102084472699</c:v>
                </c:pt>
                <c:pt idx="218">
                  <c:v>22.057102084472699</c:v>
                </c:pt>
                <c:pt idx="219">
                  <c:v>22.057102084472699</c:v>
                </c:pt>
                <c:pt idx="220">
                  <c:v>22.057102084472699</c:v>
                </c:pt>
                <c:pt idx="221">
                  <c:v>22.097103000000001</c:v>
                </c:pt>
                <c:pt idx="222">
                  <c:v>22.0671023133545</c:v>
                </c:pt>
                <c:pt idx="223">
                  <c:v>22.057102084472699</c:v>
                </c:pt>
                <c:pt idx="224">
                  <c:v>22.077102542236297</c:v>
                </c:pt>
                <c:pt idx="225">
                  <c:v>22.277103305175796</c:v>
                </c:pt>
                <c:pt idx="226">
                  <c:v>22.417102694824202</c:v>
                </c:pt>
                <c:pt idx="227">
                  <c:v>22.457103610351602</c:v>
                </c:pt>
                <c:pt idx="228">
                  <c:v>22.497102618530295</c:v>
                </c:pt>
                <c:pt idx="229">
                  <c:v>22.557102084472699</c:v>
                </c:pt>
                <c:pt idx="230">
                  <c:v>22.477102160766602</c:v>
                </c:pt>
                <c:pt idx="231">
                  <c:v>22.2971037629395</c:v>
                </c:pt>
                <c:pt idx="232">
                  <c:v>22.087102771118197</c:v>
                </c:pt>
                <c:pt idx="233">
                  <c:v>22.450990118530299</c:v>
                </c:pt>
                <c:pt idx="234">
                  <c:v>22.170991339233399</c:v>
                </c:pt>
                <c:pt idx="235">
                  <c:v>22.410989584472699</c:v>
                </c:pt>
                <c:pt idx="236">
                  <c:v>22.310991110351605</c:v>
                </c:pt>
                <c:pt idx="237">
                  <c:v>22.430991186645503</c:v>
                </c:pt>
                <c:pt idx="238">
                  <c:v>22.550991262939501</c:v>
                </c:pt>
                <c:pt idx="239">
                  <c:v>22.2509901185303</c:v>
                </c:pt>
                <c:pt idx="240">
                  <c:v>22.2009908814697</c:v>
                </c:pt>
                <c:pt idx="241">
                  <c:v>22.2009908814697</c:v>
                </c:pt>
                <c:pt idx="242">
                  <c:v>22.190990652587903</c:v>
                </c:pt>
                <c:pt idx="243">
                  <c:v>22.170990194824206</c:v>
                </c:pt>
                <c:pt idx="244">
                  <c:v>22.180990423706106</c:v>
                </c:pt>
                <c:pt idx="245">
                  <c:v>22.170990194824206</c:v>
                </c:pt>
                <c:pt idx="246">
                  <c:v>22.13099118664551</c:v>
                </c:pt>
                <c:pt idx="247">
                  <c:v>22.120990957763702</c:v>
                </c:pt>
                <c:pt idx="248">
                  <c:v>22.150989737060506</c:v>
                </c:pt>
                <c:pt idx="249">
                  <c:v>22.13099118664551</c:v>
                </c:pt>
                <c:pt idx="250">
                  <c:v>22.120990957763702</c:v>
                </c:pt>
                <c:pt idx="251">
                  <c:v>22.110990728881809</c:v>
                </c:pt>
                <c:pt idx="252">
                  <c:v>22.110990728881809</c:v>
                </c:pt>
                <c:pt idx="253">
                  <c:v>22.110990728881809</c:v>
                </c:pt>
                <c:pt idx="254">
                  <c:v>22.110990728881809</c:v>
                </c:pt>
                <c:pt idx="255">
                  <c:v>22.450990118530299</c:v>
                </c:pt>
                <c:pt idx="256">
                  <c:v>22.170991339233399</c:v>
                </c:pt>
                <c:pt idx="257">
                  <c:v>22.310989584472701</c:v>
                </c:pt>
                <c:pt idx="258">
                  <c:v>22.310991110351605</c:v>
                </c:pt>
                <c:pt idx="259">
                  <c:v>22.2009908814697</c:v>
                </c:pt>
                <c:pt idx="260">
                  <c:v>22.190990652587903</c:v>
                </c:pt>
                <c:pt idx="261">
                  <c:v>22.170990194824206</c:v>
                </c:pt>
                <c:pt idx="262">
                  <c:v>22.477102160766602</c:v>
                </c:pt>
                <c:pt idx="263">
                  <c:v>22.257102847412099</c:v>
                </c:pt>
                <c:pt idx="264">
                  <c:v>22.237102389648399</c:v>
                </c:pt>
                <c:pt idx="265">
                  <c:v>22.247102618530295</c:v>
                </c:pt>
                <c:pt idx="266">
                  <c:v>22.237102389648399</c:v>
                </c:pt>
                <c:pt idx="267">
                  <c:v>22.257102847412099</c:v>
                </c:pt>
                <c:pt idx="268">
                  <c:v>22.257102847412099</c:v>
                </c:pt>
                <c:pt idx="269">
                  <c:v>22.267103076293896</c:v>
                </c:pt>
                <c:pt idx="270">
                  <c:v>22.257102847412099</c:v>
                </c:pt>
                <c:pt idx="271">
                  <c:v>22.237102389648399</c:v>
                </c:pt>
                <c:pt idx="272">
                  <c:v>22.227102160766602</c:v>
                </c:pt>
                <c:pt idx="273">
                  <c:v>22.217103839233395</c:v>
                </c:pt>
                <c:pt idx="274">
                  <c:v>22.217103839233395</c:v>
                </c:pt>
                <c:pt idx="275">
                  <c:v>22.217103839233395</c:v>
                </c:pt>
                <c:pt idx="276">
                  <c:v>22.197103381469702</c:v>
                </c:pt>
                <c:pt idx="277">
                  <c:v>22.227102160766602</c:v>
                </c:pt>
                <c:pt idx="278">
                  <c:v>22.207103610351602</c:v>
                </c:pt>
                <c:pt idx="279">
                  <c:v>22.207103610351602</c:v>
                </c:pt>
                <c:pt idx="280">
                  <c:v>22.187103152587902</c:v>
                </c:pt>
                <c:pt idx="281">
                  <c:v>22.197103381469702</c:v>
                </c:pt>
                <c:pt idx="282">
                  <c:v>22.177102923706101</c:v>
                </c:pt>
                <c:pt idx="283">
                  <c:v>22.187103152587902</c:v>
                </c:pt>
                <c:pt idx="284">
                  <c:v>22.197103381469702</c:v>
                </c:pt>
                <c:pt idx="285">
                  <c:v>22.137103915527302</c:v>
                </c:pt>
                <c:pt idx="286">
                  <c:v>22.127103686645501</c:v>
                </c:pt>
                <c:pt idx="287">
                  <c:v>22.117103457763701</c:v>
                </c:pt>
                <c:pt idx="288">
                  <c:v>22.127103686645501</c:v>
                </c:pt>
                <c:pt idx="289">
                  <c:v>22.117103457763701</c:v>
                </c:pt>
                <c:pt idx="290">
                  <c:v>22.107103228881801</c:v>
                </c:pt>
                <c:pt idx="291">
                  <c:v>22.457103610351602</c:v>
                </c:pt>
                <c:pt idx="292">
                  <c:v>22.497102618530295</c:v>
                </c:pt>
                <c:pt idx="293">
                  <c:v>22.371020844726996</c:v>
                </c:pt>
                <c:pt idx="294">
                  <c:v>22.477102160766602</c:v>
                </c:pt>
                <c:pt idx="295">
                  <c:v>22.2971037629395</c:v>
                </c:pt>
                <c:pt idx="296">
                  <c:v>22.087102771118197</c:v>
                </c:pt>
                <c:pt idx="297">
                  <c:v>22.450990118530299</c:v>
                </c:pt>
                <c:pt idx="298">
                  <c:v>22.170991339233399</c:v>
                </c:pt>
                <c:pt idx="299">
                  <c:v>22.810989584472701</c:v>
                </c:pt>
                <c:pt idx="300">
                  <c:v>22.710991110351607</c:v>
                </c:pt>
                <c:pt idx="301">
                  <c:v>22.63099118664551</c:v>
                </c:pt>
                <c:pt idx="302">
                  <c:v>22.550991262939501</c:v>
                </c:pt>
                <c:pt idx="303">
                  <c:v>22.4909898896484</c:v>
                </c:pt>
                <c:pt idx="304">
                  <c:v>22.4509908814697</c:v>
                </c:pt>
                <c:pt idx="305">
                  <c:v>22.390991415527303</c:v>
                </c:pt>
                <c:pt idx="306">
                  <c:v>22.350990500000005</c:v>
                </c:pt>
                <c:pt idx="307">
                  <c:v>22.330990042236301</c:v>
                </c:pt>
                <c:pt idx="308">
                  <c:v>22.320989813354501</c:v>
                </c:pt>
                <c:pt idx="309">
                  <c:v>22.270990576293897</c:v>
                </c:pt>
                <c:pt idx="310">
                  <c:v>22.280990805175794</c:v>
                </c:pt>
                <c:pt idx="311">
                  <c:v>22.2409898896484</c:v>
                </c:pt>
                <c:pt idx="312">
                  <c:v>22.2509901185303</c:v>
                </c:pt>
                <c:pt idx="313">
                  <c:v>22.2009908814697</c:v>
                </c:pt>
                <c:pt idx="314">
                  <c:v>22.2009908814697</c:v>
                </c:pt>
                <c:pt idx="315">
                  <c:v>22.190990652587903</c:v>
                </c:pt>
                <c:pt idx="316">
                  <c:v>22.170990194824206</c:v>
                </c:pt>
                <c:pt idx="317">
                  <c:v>22.180990423706106</c:v>
                </c:pt>
                <c:pt idx="318">
                  <c:v>22.170990194824206</c:v>
                </c:pt>
                <c:pt idx="319">
                  <c:v>22.13099118664551</c:v>
                </c:pt>
                <c:pt idx="320">
                  <c:v>22.120990957763702</c:v>
                </c:pt>
                <c:pt idx="321">
                  <c:v>22.150989737060506</c:v>
                </c:pt>
                <c:pt idx="322">
                  <c:v>22.13099118664551</c:v>
                </c:pt>
                <c:pt idx="323">
                  <c:v>22.120990957763702</c:v>
                </c:pt>
                <c:pt idx="324">
                  <c:v>22.110990728881809</c:v>
                </c:pt>
                <c:pt idx="325">
                  <c:v>22.2971037629395</c:v>
                </c:pt>
                <c:pt idx="326">
                  <c:v>22.087102771118197</c:v>
                </c:pt>
                <c:pt idx="327">
                  <c:v>22.450990118530299</c:v>
                </c:pt>
                <c:pt idx="328">
                  <c:v>22.170991339233399</c:v>
                </c:pt>
                <c:pt idx="329">
                  <c:v>22.810989584472701</c:v>
                </c:pt>
                <c:pt idx="330">
                  <c:v>22.390991415527303</c:v>
                </c:pt>
                <c:pt idx="331">
                  <c:v>22.097103000000001</c:v>
                </c:pt>
                <c:pt idx="332">
                  <c:v>22.087102771118197</c:v>
                </c:pt>
                <c:pt idx="333">
                  <c:v>22.077102542236297</c:v>
                </c:pt>
                <c:pt idx="334">
                  <c:v>22.097103000000001</c:v>
                </c:pt>
                <c:pt idx="335">
                  <c:v>22.077102542236297</c:v>
                </c:pt>
                <c:pt idx="336">
                  <c:v>22.0671023133545</c:v>
                </c:pt>
                <c:pt idx="337">
                  <c:v>22.077102542236297</c:v>
                </c:pt>
                <c:pt idx="338">
                  <c:v>22.0671023133545</c:v>
                </c:pt>
                <c:pt idx="339">
                  <c:v>22.057102084472699</c:v>
                </c:pt>
                <c:pt idx="340">
                  <c:v>22.170990194824206</c:v>
                </c:pt>
                <c:pt idx="341">
                  <c:v>22.180990423706106</c:v>
                </c:pt>
                <c:pt idx="342">
                  <c:v>22.170990194824206</c:v>
                </c:pt>
                <c:pt idx="343">
                  <c:v>22.13099118664551</c:v>
                </c:pt>
                <c:pt idx="344">
                  <c:v>22.120990957763702</c:v>
                </c:pt>
                <c:pt idx="345">
                  <c:v>22.150989737060506</c:v>
                </c:pt>
                <c:pt idx="346">
                  <c:v>22.1309911866455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8564608"/>
        <c:axId val="148563072"/>
      </c:scatterChart>
      <c:valAx>
        <c:axId val="148559744"/>
        <c:scaling>
          <c:orientation val="minMax"/>
          <c:max val="35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txPr>
          <a:bodyPr/>
          <a:lstStyle/>
          <a:p>
            <a:pPr>
              <a:defRPr sz="7000" b="1"/>
            </a:pPr>
            <a:endParaRPr lang="de-DE"/>
          </a:p>
        </c:txPr>
        <c:crossAx val="148561280"/>
        <c:crosses val="autoZero"/>
        <c:crossBetween val="midCat"/>
        <c:majorUnit val="500"/>
      </c:valAx>
      <c:valAx>
        <c:axId val="148561280"/>
        <c:scaling>
          <c:orientation val="minMax"/>
          <c:max val="12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txPr>
          <a:bodyPr/>
          <a:lstStyle/>
          <a:p>
            <a:pPr>
              <a:defRPr sz="7000" b="1"/>
            </a:pPr>
            <a:endParaRPr lang="de-DE"/>
          </a:p>
        </c:txPr>
        <c:crossAx val="148559744"/>
        <c:crosses val="autoZero"/>
        <c:crossBetween val="midCat"/>
      </c:valAx>
      <c:valAx>
        <c:axId val="148563072"/>
        <c:scaling>
          <c:orientation val="minMax"/>
          <c:max val="40"/>
          <c:min val="1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txPr>
          <a:bodyPr/>
          <a:lstStyle/>
          <a:p>
            <a:pPr>
              <a:defRPr sz="7000" b="1"/>
            </a:pPr>
            <a:endParaRPr lang="de-DE"/>
          </a:p>
        </c:txPr>
        <c:crossAx val="148564608"/>
        <c:crosses val="max"/>
        <c:crossBetween val="midCat"/>
      </c:valAx>
      <c:valAx>
        <c:axId val="1485646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148563072"/>
        <c:crosses val="autoZero"/>
        <c:crossBetween val="midCat"/>
      </c:valAx>
      <c:spPr>
        <a:noFill/>
        <a:ln w="10160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7B0969-A96C-4ABD-94C5-8AC2F223136E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32FB92-C862-4661-B766-3EE756AC2CB5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01100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700338" y="11184734"/>
            <a:ext cx="30603825" cy="771763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5400675" y="20402550"/>
            <a:ext cx="25203150" cy="92011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114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172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229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287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34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4401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6459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09677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559003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102781598" y="7567613"/>
            <a:ext cx="31897735" cy="1612868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7088386" y="7567613"/>
            <a:ext cx="95093137" cy="1612868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6494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52168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844107" y="23136228"/>
            <a:ext cx="30603825" cy="7150894"/>
          </a:xfrm>
        </p:spPr>
        <p:txBody>
          <a:bodyPr anchor="t"/>
          <a:lstStyle>
            <a:lvl1pPr algn="l">
              <a:defRPr sz="18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844107" y="15260246"/>
            <a:ext cx="30603825" cy="7875982"/>
          </a:xfrm>
        </p:spPr>
        <p:txBody>
          <a:bodyPr anchor="b"/>
          <a:lstStyle>
            <a:lvl1pPr marL="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1pPr>
            <a:lvl2pPr marL="2057400" indent="0">
              <a:buNone/>
              <a:defRPr sz="8100">
                <a:solidFill>
                  <a:schemeClr val="tx1">
                    <a:tint val="75000"/>
                  </a:schemeClr>
                </a:solidFill>
              </a:defRPr>
            </a:lvl2pPr>
            <a:lvl3pPr marL="41148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3pPr>
            <a:lvl4pPr marL="61722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4pPr>
            <a:lvl5pPr marL="82296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5pPr>
            <a:lvl6pPr marL="102870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6pPr>
            <a:lvl7pPr marL="123444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7pPr>
            <a:lvl8pPr marL="144018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8pPr>
            <a:lvl9pPr marL="164592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022394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7088388" y="44105512"/>
            <a:ext cx="63495436" cy="124748925"/>
          </a:xfrm>
        </p:spPr>
        <p:txBody>
          <a:bodyPr/>
          <a:lstStyle>
            <a:lvl1pPr>
              <a:defRPr sz="12600"/>
            </a:lvl1pPr>
            <a:lvl2pPr>
              <a:defRPr sz="10800"/>
            </a:lvl2pPr>
            <a:lvl3pPr>
              <a:defRPr sz="9000"/>
            </a:lvl3pPr>
            <a:lvl4pPr>
              <a:defRPr sz="8100"/>
            </a:lvl4pPr>
            <a:lvl5pPr>
              <a:defRPr sz="8100"/>
            </a:lvl5pPr>
            <a:lvl6pPr>
              <a:defRPr sz="8100"/>
            </a:lvl6pPr>
            <a:lvl7pPr>
              <a:defRPr sz="8100"/>
            </a:lvl7pPr>
            <a:lvl8pPr>
              <a:defRPr sz="8100"/>
            </a:lvl8pPr>
            <a:lvl9pPr>
              <a:defRPr sz="81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71183899" y="44105512"/>
            <a:ext cx="63495436" cy="124748925"/>
          </a:xfrm>
        </p:spPr>
        <p:txBody>
          <a:bodyPr/>
          <a:lstStyle>
            <a:lvl1pPr>
              <a:defRPr sz="12600"/>
            </a:lvl1pPr>
            <a:lvl2pPr>
              <a:defRPr sz="10800"/>
            </a:lvl2pPr>
            <a:lvl3pPr>
              <a:defRPr sz="9000"/>
            </a:lvl3pPr>
            <a:lvl4pPr>
              <a:defRPr sz="8100"/>
            </a:lvl4pPr>
            <a:lvl5pPr>
              <a:defRPr sz="8100"/>
            </a:lvl5pPr>
            <a:lvl6pPr>
              <a:defRPr sz="8100"/>
            </a:lvl6pPr>
            <a:lvl7pPr>
              <a:defRPr sz="8100"/>
            </a:lvl7pPr>
            <a:lvl8pPr>
              <a:defRPr sz="8100"/>
            </a:lvl8pPr>
            <a:lvl9pPr>
              <a:defRPr sz="81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14347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800225" y="1441849"/>
            <a:ext cx="32404050" cy="600075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800225" y="8059343"/>
            <a:ext cx="15908240" cy="3358751"/>
          </a:xfrm>
        </p:spPr>
        <p:txBody>
          <a:bodyPr anchor="b"/>
          <a:lstStyle>
            <a:lvl1pPr marL="0" indent="0">
              <a:buNone/>
              <a:defRPr sz="10800" b="1"/>
            </a:lvl1pPr>
            <a:lvl2pPr marL="2057400" indent="0">
              <a:buNone/>
              <a:defRPr sz="9000" b="1"/>
            </a:lvl2pPr>
            <a:lvl3pPr marL="4114800" indent="0">
              <a:buNone/>
              <a:defRPr sz="8100" b="1"/>
            </a:lvl3pPr>
            <a:lvl4pPr marL="6172200" indent="0">
              <a:buNone/>
              <a:defRPr sz="7200" b="1"/>
            </a:lvl4pPr>
            <a:lvl5pPr marL="8229600" indent="0">
              <a:buNone/>
              <a:defRPr sz="7200" b="1"/>
            </a:lvl5pPr>
            <a:lvl6pPr marL="10287000" indent="0">
              <a:buNone/>
              <a:defRPr sz="7200" b="1"/>
            </a:lvl6pPr>
            <a:lvl7pPr marL="12344400" indent="0">
              <a:buNone/>
              <a:defRPr sz="7200" b="1"/>
            </a:lvl7pPr>
            <a:lvl8pPr marL="14401800" indent="0">
              <a:buNone/>
              <a:defRPr sz="7200" b="1"/>
            </a:lvl8pPr>
            <a:lvl9pPr marL="16459200" indent="0">
              <a:buNone/>
              <a:defRPr sz="7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800225" y="11418094"/>
            <a:ext cx="15908240" cy="20744262"/>
          </a:xfrm>
        </p:spPr>
        <p:txBody>
          <a:bodyPr/>
          <a:lstStyle>
            <a:lvl1pPr>
              <a:defRPr sz="10800"/>
            </a:lvl1pPr>
            <a:lvl2pPr>
              <a:defRPr sz="9000"/>
            </a:lvl2pPr>
            <a:lvl3pPr>
              <a:defRPr sz="81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18289788" y="8059343"/>
            <a:ext cx="15914489" cy="3358751"/>
          </a:xfrm>
        </p:spPr>
        <p:txBody>
          <a:bodyPr anchor="b"/>
          <a:lstStyle>
            <a:lvl1pPr marL="0" indent="0">
              <a:buNone/>
              <a:defRPr sz="10800" b="1"/>
            </a:lvl1pPr>
            <a:lvl2pPr marL="2057400" indent="0">
              <a:buNone/>
              <a:defRPr sz="9000" b="1"/>
            </a:lvl2pPr>
            <a:lvl3pPr marL="4114800" indent="0">
              <a:buNone/>
              <a:defRPr sz="8100" b="1"/>
            </a:lvl3pPr>
            <a:lvl4pPr marL="6172200" indent="0">
              <a:buNone/>
              <a:defRPr sz="7200" b="1"/>
            </a:lvl4pPr>
            <a:lvl5pPr marL="8229600" indent="0">
              <a:buNone/>
              <a:defRPr sz="7200" b="1"/>
            </a:lvl5pPr>
            <a:lvl6pPr marL="10287000" indent="0">
              <a:buNone/>
              <a:defRPr sz="7200" b="1"/>
            </a:lvl6pPr>
            <a:lvl7pPr marL="12344400" indent="0">
              <a:buNone/>
              <a:defRPr sz="7200" b="1"/>
            </a:lvl7pPr>
            <a:lvl8pPr marL="14401800" indent="0">
              <a:buNone/>
              <a:defRPr sz="7200" b="1"/>
            </a:lvl8pPr>
            <a:lvl9pPr marL="16459200" indent="0">
              <a:buNone/>
              <a:defRPr sz="7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18289788" y="11418094"/>
            <a:ext cx="15914489" cy="20744262"/>
          </a:xfrm>
        </p:spPr>
        <p:txBody>
          <a:bodyPr/>
          <a:lstStyle>
            <a:lvl1pPr>
              <a:defRPr sz="10800"/>
            </a:lvl1pPr>
            <a:lvl2pPr>
              <a:defRPr sz="9000"/>
            </a:lvl2pPr>
            <a:lvl3pPr>
              <a:defRPr sz="81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40312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35698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00417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800227" y="1433512"/>
            <a:ext cx="11845232" cy="6100763"/>
          </a:xfrm>
        </p:spPr>
        <p:txBody>
          <a:bodyPr anchor="b"/>
          <a:lstStyle>
            <a:lvl1pPr algn="l">
              <a:defRPr sz="9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14076759" y="1433515"/>
            <a:ext cx="20127516" cy="30728843"/>
          </a:xfrm>
        </p:spPr>
        <p:txBody>
          <a:bodyPr/>
          <a:lstStyle>
            <a:lvl1pPr>
              <a:defRPr sz="14400"/>
            </a:lvl1pPr>
            <a:lvl2pPr>
              <a:defRPr sz="12600"/>
            </a:lvl2pPr>
            <a:lvl3pPr>
              <a:defRPr sz="10800"/>
            </a:lvl3pPr>
            <a:lvl4pPr>
              <a:defRPr sz="9000"/>
            </a:lvl4pPr>
            <a:lvl5pPr>
              <a:defRPr sz="9000"/>
            </a:lvl5pPr>
            <a:lvl6pPr>
              <a:defRPr sz="9000"/>
            </a:lvl6pPr>
            <a:lvl7pPr>
              <a:defRPr sz="9000"/>
            </a:lvl7pPr>
            <a:lvl8pPr>
              <a:defRPr sz="9000"/>
            </a:lvl8pPr>
            <a:lvl9pPr>
              <a:defRPr sz="9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800227" y="7534278"/>
            <a:ext cx="11845232" cy="24628081"/>
          </a:xfrm>
        </p:spPr>
        <p:txBody>
          <a:bodyPr/>
          <a:lstStyle>
            <a:lvl1pPr marL="0" indent="0">
              <a:buNone/>
              <a:defRPr sz="6300"/>
            </a:lvl1pPr>
            <a:lvl2pPr marL="2057400" indent="0">
              <a:buNone/>
              <a:defRPr sz="5400"/>
            </a:lvl2pPr>
            <a:lvl3pPr marL="4114800" indent="0">
              <a:buNone/>
              <a:defRPr sz="4500"/>
            </a:lvl3pPr>
            <a:lvl4pPr marL="6172200" indent="0">
              <a:buNone/>
              <a:defRPr sz="4100"/>
            </a:lvl4pPr>
            <a:lvl5pPr marL="8229600" indent="0">
              <a:buNone/>
              <a:defRPr sz="4100"/>
            </a:lvl5pPr>
            <a:lvl6pPr marL="10287000" indent="0">
              <a:buNone/>
              <a:defRPr sz="4100"/>
            </a:lvl6pPr>
            <a:lvl7pPr marL="12344400" indent="0">
              <a:buNone/>
              <a:defRPr sz="4100"/>
            </a:lvl7pPr>
            <a:lvl8pPr marL="14401800" indent="0">
              <a:buNone/>
              <a:defRPr sz="4100"/>
            </a:lvl8pPr>
            <a:lvl9pPr marL="16459200" indent="0">
              <a:buNone/>
              <a:defRPr sz="41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9037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057134" y="25203150"/>
            <a:ext cx="21602700" cy="2975375"/>
          </a:xfrm>
        </p:spPr>
        <p:txBody>
          <a:bodyPr anchor="b"/>
          <a:lstStyle>
            <a:lvl1pPr algn="l">
              <a:defRPr sz="9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7057134" y="3217069"/>
            <a:ext cx="21602700" cy="21602700"/>
          </a:xfrm>
        </p:spPr>
        <p:txBody>
          <a:bodyPr/>
          <a:lstStyle>
            <a:lvl1pPr marL="0" indent="0">
              <a:buNone/>
              <a:defRPr sz="14400"/>
            </a:lvl1pPr>
            <a:lvl2pPr marL="2057400" indent="0">
              <a:buNone/>
              <a:defRPr sz="12600"/>
            </a:lvl2pPr>
            <a:lvl3pPr marL="4114800" indent="0">
              <a:buNone/>
              <a:defRPr sz="10800"/>
            </a:lvl3pPr>
            <a:lvl4pPr marL="6172200" indent="0">
              <a:buNone/>
              <a:defRPr sz="9000"/>
            </a:lvl4pPr>
            <a:lvl5pPr marL="8229600" indent="0">
              <a:buNone/>
              <a:defRPr sz="9000"/>
            </a:lvl5pPr>
            <a:lvl6pPr marL="10287000" indent="0">
              <a:buNone/>
              <a:defRPr sz="9000"/>
            </a:lvl6pPr>
            <a:lvl7pPr marL="12344400" indent="0">
              <a:buNone/>
              <a:defRPr sz="9000"/>
            </a:lvl7pPr>
            <a:lvl8pPr marL="14401800" indent="0">
              <a:buNone/>
              <a:defRPr sz="9000"/>
            </a:lvl8pPr>
            <a:lvl9pPr marL="16459200" indent="0">
              <a:buNone/>
              <a:defRPr sz="9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7057134" y="28178524"/>
            <a:ext cx="21602700" cy="4225526"/>
          </a:xfrm>
        </p:spPr>
        <p:txBody>
          <a:bodyPr/>
          <a:lstStyle>
            <a:lvl1pPr marL="0" indent="0">
              <a:buNone/>
              <a:defRPr sz="6300"/>
            </a:lvl1pPr>
            <a:lvl2pPr marL="2057400" indent="0">
              <a:buNone/>
              <a:defRPr sz="5400"/>
            </a:lvl2pPr>
            <a:lvl3pPr marL="4114800" indent="0">
              <a:buNone/>
              <a:defRPr sz="4500"/>
            </a:lvl3pPr>
            <a:lvl4pPr marL="6172200" indent="0">
              <a:buNone/>
              <a:defRPr sz="4100"/>
            </a:lvl4pPr>
            <a:lvl5pPr marL="8229600" indent="0">
              <a:buNone/>
              <a:defRPr sz="4100"/>
            </a:lvl5pPr>
            <a:lvl6pPr marL="10287000" indent="0">
              <a:buNone/>
              <a:defRPr sz="4100"/>
            </a:lvl6pPr>
            <a:lvl7pPr marL="12344400" indent="0">
              <a:buNone/>
              <a:defRPr sz="4100"/>
            </a:lvl7pPr>
            <a:lvl8pPr marL="14401800" indent="0">
              <a:buNone/>
              <a:defRPr sz="4100"/>
            </a:lvl8pPr>
            <a:lvl9pPr marL="16459200" indent="0">
              <a:buNone/>
              <a:defRPr sz="41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778536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1800225" y="1441849"/>
            <a:ext cx="32404050" cy="6000750"/>
          </a:xfrm>
          <a:prstGeom prst="rect">
            <a:avLst/>
          </a:prstGeom>
        </p:spPr>
        <p:txBody>
          <a:bodyPr vert="horz" lIns="411480" tIns="205740" rIns="411480" bIns="20574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800225" y="8401053"/>
            <a:ext cx="32404050" cy="23761306"/>
          </a:xfrm>
          <a:prstGeom prst="rect">
            <a:avLst/>
          </a:prstGeom>
        </p:spPr>
        <p:txBody>
          <a:bodyPr vert="horz" lIns="411480" tIns="205740" rIns="411480" bIns="20574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1800225" y="33370840"/>
            <a:ext cx="8401050" cy="1916906"/>
          </a:xfrm>
          <a:prstGeom prst="rect">
            <a:avLst/>
          </a:prstGeom>
        </p:spPr>
        <p:txBody>
          <a:bodyPr vert="horz" lIns="411480" tIns="205740" rIns="411480" bIns="205740" rtlCol="0" anchor="ctr"/>
          <a:lstStyle>
            <a:lvl1pPr algn="l">
              <a:defRPr sz="5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C3BFF-BD21-4F34-8360-798EFAE94062}" type="datetimeFigureOut">
              <a:rPr lang="de-AT" smtClean="0"/>
              <a:pPr/>
              <a:t>22.07.2015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12301538" y="33370840"/>
            <a:ext cx="11401425" cy="1916906"/>
          </a:xfrm>
          <a:prstGeom prst="rect">
            <a:avLst/>
          </a:prstGeom>
        </p:spPr>
        <p:txBody>
          <a:bodyPr vert="horz" lIns="411480" tIns="205740" rIns="411480" bIns="205740" rtlCol="0" anchor="ctr"/>
          <a:lstStyle>
            <a:lvl1pPr algn="ctr">
              <a:defRPr sz="5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25803225" y="33370840"/>
            <a:ext cx="8401050" cy="1916906"/>
          </a:xfrm>
          <a:prstGeom prst="rect">
            <a:avLst/>
          </a:prstGeom>
        </p:spPr>
        <p:txBody>
          <a:bodyPr vert="horz" lIns="411480" tIns="205740" rIns="411480" bIns="205740" rtlCol="0" anchor="ctr"/>
          <a:lstStyle>
            <a:lvl1pPr algn="r">
              <a:defRPr sz="5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07A5A-5DC5-4704-B9F6-190A8E6B39B3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27943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14800" rtl="0" eaLnBrk="1" latinLnBrk="0" hangingPunct="1">
        <a:spcBef>
          <a:spcPct val="0"/>
        </a:spcBef>
        <a:buNone/>
        <a:defRPr sz="19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43050" indent="-1543050" algn="l" defTabSz="4114800" rtl="0" eaLnBrk="1" latinLnBrk="0" hangingPunct="1">
        <a:spcBef>
          <a:spcPct val="20000"/>
        </a:spcBef>
        <a:buFont typeface="Arial" pitchFamily="34" charset="0"/>
        <a:buChar char="•"/>
        <a:defRPr sz="14400" kern="1200">
          <a:solidFill>
            <a:schemeClr val="tx1"/>
          </a:solidFill>
          <a:latin typeface="+mn-lt"/>
          <a:ea typeface="+mn-ea"/>
          <a:cs typeface="+mn-cs"/>
        </a:defRPr>
      </a:lvl1pPr>
      <a:lvl2pPr marL="3343275" indent="-1285875" algn="l" defTabSz="4114800" rtl="0" eaLnBrk="1" latinLnBrk="0" hangingPunct="1">
        <a:spcBef>
          <a:spcPct val="20000"/>
        </a:spcBef>
        <a:buFont typeface="Arial" pitchFamily="34" charset="0"/>
        <a:buChar char="–"/>
        <a:defRPr sz="12600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10800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0" indent="-1028700" algn="l" defTabSz="4114800" rtl="0" eaLnBrk="1" latinLnBrk="0" hangingPunct="1">
        <a:spcBef>
          <a:spcPct val="20000"/>
        </a:spcBef>
        <a:buFont typeface="Arial" pitchFamily="34" charset="0"/>
        <a:buChar char="–"/>
        <a:defRPr sz="9000" kern="1200">
          <a:solidFill>
            <a:schemeClr val="tx1"/>
          </a:solidFill>
          <a:latin typeface="+mn-lt"/>
          <a:ea typeface="+mn-ea"/>
          <a:cs typeface="+mn-cs"/>
        </a:defRPr>
      </a:lvl4pPr>
      <a:lvl5pPr marL="9258300" indent="-1028700" algn="l" defTabSz="4114800" rtl="0" eaLnBrk="1" latinLnBrk="0" hangingPunct="1">
        <a:spcBef>
          <a:spcPct val="20000"/>
        </a:spcBef>
        <a:buFont typeface="Arial" pitchFamily="34" charset="0"/>
        <a:buChar char="»"/>
        <a:defRPr sz="9000" kern="1200">
          <a:solidFill>
            <a:schemeClr val="tx1"/>
          </a:solidFill>
          <a:latin typeface="+mn-lt"/>
          <a:ea typeface="+mn-ea"/>
          <a:cs typeface="+mn-cs"/>
        </a:defRPr>
      </a:lvl5pPr>
      <a:lvl6pPr marL="113157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6pPr>
      <a:lvl7pPr marL="133731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7pPr>
      <a:lvl8pPr marL="154305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8pPr>
      <a:lvl9pPr marL="174879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2pPr>
      <a:lvl3pPr marL="41148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3pPr>
      <a:lvl4pPr marL="61722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5pPr>
      <a:lvl6pPr marL="102870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6pPr>
      <a:lvl7pPr marL="123444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7pPr>
      <a:lvl8pPr marL="144018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8pPr>
      <a:lvl9pPr marL="164592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9700385" y="11176730"/>
            <a:ext cx="1970411" cy="12456000"/>
          </a:xfrm>
          <a:prstGeom prst="rect">
            <a:avLst/>
          </a:prstGeom>
          <a:solidFill>
            <a:schemeClr val="accent2">
              <a:lumMod val="20000"/>
              <a:lumOff val="80000"/>
              <a:alpha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46" name="Rechteck 45"/>
          <p:cNvSpPr/>
          <p:nvPr/>
        </p:nvSpPr>
        <p:spPr>
          <a:xfrm>
            <a:off x="11678416" y="11176729"/>
            <a:ext cx="15503604" cy="12456000"/>
          </a:xfrm>
          <a:prstGeom prst="rect">
            <a:avLst/>
          </a:prstGeom>
          <a:solidFill>
            <a:schemeClr val="accent5">
              <a:lumMod val="20000"/>
              <a:lumOff val="80000"/>
              <a:alpha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cxnSp>
        <p:nvCxnSpPr>
          <p:cNvPr id="9" name="Gerade Verbindung 8"/>
          <p:cNvCxnSpPr/>
          <p:nvPr/>
        </p:nvCxnSpPr>
        <p:spPr>
          <a:xfrm>
            <a:off x="11670796" y="11176730"/>
            <a:ext cx="0" cy="12456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feld 49"/>
          <p:cNvSpPr txBox="1"/>
          <p:nvPr/>
        </p:nvSpPr>
        <p:spPr>
          <a:xfrm>
            <a:off x="9110020" y="25691519"/>
            <a:ext cx="18072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0" b="1" dirty="0" smtClean="0"/>
              <a:t>Time (min)</a:t>
            </a:r>
            <a:endParaRPr lang="en-US" sz="7000" b="1" dirty="0"/>
          </a:p>
        </p:txBody>
      </p:sp>
      <p:sp>
        <p:nvSpPr>
          <p:cNvPr id="51" name="Textfeld 50"/>
          <p:cNvSpPr txBox="1"/>
          <p:nvPr/>
        </p:nvSpPr>
        <p:spPr>
          <a:xfrm rot="16200000">
            <a:off x="-538025" y="16740326"/>
            <a:ext cx="1261525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0" b="1" dirty="0"/>
              <a:t>Relative humidity (%)</a:t>
            </a:r>
            <a:endParaRPr lang="en-US" sz="7000" b="1" i="1" dirty="0"/>
          </a:p>
        </p:txBody>
      </p:sp>
      <p:sp>
        <p:nvSpPr>
          <p:cNvPr id="53" name="Textfeld 52"/>
          <p:cNvSpPr txBox="1"/>
          <p:nvPr/>
        </p:nvSpPr>
        <p:spPr>
          <a:xfrm rot="5400000">
            <a:off x="23894454" y="16740326"/>
            <a:ext cx="1261525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0" b="1" dirty="0" smtClean="0"/>
              <a:t>Temperature (°C)</a:t>
            </a:r>
            <a:endParaRPr lang="en-US" sz="7000" b="1" i="1" dirty="0"/>
          </a:p>
        </p:txBody>
      </p:sp>
      <p:sp>
        <p:nvSpPr>
          <p:cNvPr id="13" name="Geschweifte Klammer rechts 12"/>
          <p:cNvSpPr/>
          <p:nvPr/>
        </p:nvSpPr>
        <p:spPr>
          <a:xfrm rot="16200000">
            <a:off x="10325591" y="9600255"/>
            <a:ext cx="720002" cy="1970412"/>
          </a:xfrm>
          <a:prstGeom prst="rightBrace">
            <a:avLst>
              <a:gd name="adj1" fmla="val 0"/>
              <a:gd name="adj2" fmla="val 50000"/>
            </a:avLst>
          </a:prstGeom>
          <a:noFill/>
          <a:ln w="1016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55" name="Geschweifte Klammer rechts 54"/>
          <p:cNvSpPr/>
          <p:nvPr/>
        </p:nvSpPr>
        <p:spPr>
          <a:xfrm rot="16200000">
            <a:off x="19066409" y="2829854"/>
            <a:ext cx="720000" cy="15511221"/>
          </a:xfrm>
          <a:prstGeom prst="rightBrace">
            <a:avLst>
              <a:gd name="adj1" fmla="val 0"/>
              <a:gd name="adj2" fmla="val 50000"/>
            </a:avLst>
          </a:prstGeom>
          <a:noFill/>
          <a:ln w="1016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56" name="Textfeld 55"/>
          <p:cNvSpPr txBox="1"/>
          <p:nvPr/>
        </p:nvSpPr>
        <p:spPr>
          <a:xfrm>
            <a:off x="9680610" y="8976871"/>
            <a:ext cx="200923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0" b="1" dirty="0" smtClean="0"/>
              <a:t>Des.</a:t>
            </a:r>
            <a:endParaRPr lang="en-US" sz="7000" b="1" i="1" dirty="0"/>
          </a:p>
        </p:txBody>
      </p:sp>
      <p:sp>
        <p:nvSpPr>
          <p:cNvPr id="57" name="Textfeld 56"/>
          <p:cNvSpPr txBox="1"/>
          <p:nvPr/>
        </p:nvSpPr>
        <p:spPr>
          <a:xfrm>
            <a:off x="16087096" y="8976871"/>
            <a:ext cx="667445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0" b="1" dirty="0" smtClean="0"/>
              <a:t>Rehydration</a:t>
            </a:r>
            <a:endParaRPr lang="en-US" sz="7000" b="1" i="1" dirty="0"/>
          </a:p>
        </p:txBody>
      </p:sp>
      <p:cxnSp>
        <p:nvCxnSpPr>
          <p:cNvPr id="26" name="Gerade Verbindung 25"/>
          <p:cNvCxnSpPr/>
          <p:nvPr/>
        </p:nvCxnSpPr>
        <p:spPr>
          <a:xfrm>
            <a:off x="9700385" y="11176730"/>
            <a:ext cx="0" cy="12456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14630506" y="14933677"/>
            <a:ext cx="1184003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3314700" algn="r"/>
                <a:tab pos="3771900" algn="l"/>
                <a:tab pos="10229850" algn="ctr"/>
                <a:tab pos="20373975" algn="r"/>
              </a:tabLst>
            </a:pPr>
            <a:r>
              <a:rPr lang="en-US" sz="7000" b="1" dirty="0">
                <a:sym typeface="Wingdings"/>
              </a:rPr>
              <a:t>	</a:t>
            </a:r>
            <a:r>
              <a:rPr lang="en-US" sz="7000" b="1" dirty="0">
                <a:solidFill>
                  <a:srgbClr val="0070C0"/>
                </a:solidFill>
                <a:sym typeface="Wingdings"/>
              </a:rPr>
              <a:t>–––</a:t>
            </a:r>
            <a:r>
              <a:rPr lang="en-US" sz="7000" b="1" dirty="0">
                <a:sym typeface="Wingdings"/>
              </a:rPr>
              <a:t>	RH</a:t>
            </a:r>
          </a:p>
          <a:p>
            <a:pPr>
              <a:tabLst>
                <a:tab pos="3314700" algn="r"/>
                <a:tab pos="3771900" algn="l"/>
                <a:tab pos="10229850" algn="ctr"/>
                <a:tab pos="20373975" algn="r"/>
              </a:tabLst>
            </a:pPr>
            <a:r>
              <a:rPr lang="en-US" sz="7000" b="1" dirty="0">
                <a:sym typeface="Wingdings"/>
              </a:rPr>
              <a:t>	</a:t>
            </a:r>
            <a:r>
              <a:rPr lang="en-US" sz="7000" b="1" dirty="0">
                <a:solidFill>
                  <a:srgbClr val="0070C0"/>
                </a:solidFill>
                <a:sym typeface="Wingdings"/>
              </a:rPr>
              <a:t> </a:t>
            </a:r>
            <a:r>
              <a:rPr lang="en-US" sz="7000" b="1" dirty="0" smtClean="0">
                <a:solidFill>
                  <a:srgbClr val="FF0000"/>
                </a:solidFill>
                <a:sym typeface="Wingdings"/>
              </a:rPr>
              <a:t>–––</a:t>
            </a:r>
            <a:r>
              <a:rPr lang="en-US" sz="7000" b="1" dirty="0" smtClean="0">
                <a:sym typeface="Wingdings"/>
              </a:rPr>
              <a:t>	Temperature</a:t>
            </a:r>
          </a:p>
        </p:txBody>
      </p:sp>
      <p:cxnSp>
        <p:nvCxnSpPr>
          <p:cNvPr id="12" name="Gerade Verbindung 11"/>
          <p:cNvCxnSpPr/>
          <p:nvPr/>
        </p:nvCxnSpPr>
        <p:spPr>
          <a:xfrm>
            <a:off x="9396097" y="9217547"/>
            <a:ext cx="2336" cy="1344185"/>
          </a:xfrm>
          <a:prstGeom prst="line">
            <a:avLst/>
          </a:prstGeom>
          <a:ln w="1016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/>
          <p:cNvSpPr txBox="1"/>
          <p:nvPr/>
        </p:nvSpPr>
        <p:spPr>
          <a:xfrm>
            <a:off x="6793684" y="8033074"/>
            <a:ext cx="520324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0" b="1" dirty="0" smtClean="0"/>
              <a:t>Adjustment</a:t>
            </a:r>
            <a:endParaRPr lang="en-US" sz="7000" b="1" i="1" dirty="0"/>
          </a:p>
        </p:txBody>
      </p:sp>
      <p:sp>
        <p:nvSpPr>
          <p:cNvPr id="33" name="Runde Klammer rechts 32"/>
          <p:cNvSpPr/>
          <p:nvPr/>
        </p:nvSpPr>
        <p:spPr>
          <a:xfrm rot="16200000">
            <a:off x="9217264" y="10462344"/>
            <a:ext cx="360003" cy="606239"/>
          </a:xfrm>
          <a:prstGeom prst="rightBracket">
            <a:avLst>
              <a:gd name="adj" fmla="val 0"/>
            </a:avLst>
          </a:prstGeom>
          <a:ln w="1016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graphicFrame>
        <p:nvGraphicFramePr>
          <p:cNvPr id="24" name="Diagramm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948542"/>
              </p:ext>
            </p:extLst>
          </p:nvPr>
        </p:nvGraphicFramePr>
        <p:xfrm>
          <a:off x="6832816" y="10585426"/>
          <a:ext cx="22158000" cy="147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93447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Benutzerdefiniert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ZID, Uni Innsbruc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laus Herburger</dc:creator>
  <cp:lastModifiedBy>Andreas Holzinger</cp:lastModifiedBy>
  <cp:revision>73</cp:revision>
  <dcterms:created xsi:type="dcterms:W3CDTF">2015-06-09T08:56:14Z</dcterms:created>
  <dcterms:modified xsi:type="dcterms:W3CDTF">2015-07-22T16:38:04Z</dcterms:modified>
</cp:coreProperties>
</file>